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aura Martin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DFD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2" autoAdjust="0"/>
    <p:restoredTop sz="94660"/>
  </p:normalViewPr>
  <p:slideViewPr>
    <p:cSldViewPr snapToGrid="0">
      <p:cViewPr varScale="1">
        <p:scale>
          <a:sx n="90" d="100"/>
          <a:sy n="90" d="100"/>
        </p:scale>
        <p:origin x="432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939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905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118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787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554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215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305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874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668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994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57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666F74-66BA-459B-9F6A-8FA928A92AA8}" type="datetimeFigureOut">
              <a:rPr lang="en-US" smtClean="0"/>
              <a:t>12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4D75B-8F25-4F96-ADC2-65BC41DAC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233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035359" y="518973"/>
            <a:ext cx="5684569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Table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altLang="en-US" sz="11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arson correlation coefficients and sample size, mean, and SD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8AD567E-AB2B-46BC-BB31-059D743153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7285000"/>
              </p:ext>
            </p:extLst>
          </p:nvPr>
        </p:nvGraphicFramePr>
        <p:xfrm>
          <a:off x="881742" y="870857"/>
          <a:ext cx="9176655" cy="5257799"/>
        </p:xfrm>
        <a:graphic>
          <a:graphicData uri="http://schemas.openxmlformats.org/drawingml/2006/table">
            <a:tbl>
              <a:tblPr firstRow="1" firstCol="1" bandRow="1"/>
              <a:tblGrid>
                <a:gridCol w="1273242">
                  <a:extLst>
                    <a:ext uri="{9D8B030D-6E8A-4147-A177-3AD203B41FA5}">
                      <a16:colId xmlns:a16="http://schemas.microsoft.com/office/drawing/2014/main" val="1488524583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3439054818"/>
                    </a:ext>
                  </a:extLst>
                </a:gridCol>
                <a:gridCol w="1195605">
                  <a:extLst>
                    <a:ext uri="{9D8B030D-6E8A-4147-A177-3AD203B41FA5}">
                      <a16:colId xmlns:a16="http://schemas.microsoft.com/office/drawing/2014/main" val="4064503772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3196960514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1029902739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1256450567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897384518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2573483376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1149481769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3787241775"/>
                    </a:ext>
                  </a:extLst>
                </a:gridCol>
                <a:gridCol w="745312">
                  <a:extLst>
                    <a:ext uri="{9D8B030D-6E8A-4147-A177-3AD203B41FA5}">
                      <a16:colId xmlns:a16="http://schemas.microsoft.com/office/drawing/2014/main" val="1389710901"/>
                    </a:ext>
                  </a:extLst>
                </a:gridCol>
              </a:tblGrid>
              <a:tr h="418669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tep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mPA</a:t>
                      </a:r>
                      <a:endParaRPr lang="en-US" sz="1100" b="1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hak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Entre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Frui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Ve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%WL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%att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-MFG/DLPF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R-MF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557455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tep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2503798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mPA</a:t>
                      </a:r>
                      <a:endParaRPr lang="en-US" sz="1100" b="1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9579162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hak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680040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Entre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950963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Frui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8233561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Ve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3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390412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%WL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9266509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%att3</a:t>
                      </a:r>
                      <a:endParaRPr lang="en-US" sz="1100" b="1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3909612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-MFG/DLPF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8824760"/>
                  </a:ext>
                </a:extLst>
              </a:tr>
              <a:tr h="40558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R-MF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-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n-US" sz="1100" b="0" i="0" u="none" strike="noStrike" kern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5164041"/>
                  </a:ext>
                </a:extLst>
              </a:tr>
              <a:tr h="28783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3139146"/>
                  </a:ext>
                </a:extLst>
              </a:tr>
              <a:tr h="287836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mea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96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0.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.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.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.7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83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1472492"/>
                  </a:ext>
                </a:extLst>
              </a:tr>
              <a:tr h="207598"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S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291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1.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9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9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12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0.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07999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402273F-33D0-4242-BA10-489879D8B7B7}"/>
              </a:ext>
            </a:extLst>
          </p:cNvPr>
          <p:cNvSpPr txBox="1"/>
          <p:nvPr/>
        </p:nvSpPr>
        <p:spPr>
          <a:xfrm>
            <a:off x="1286503" y="6232903"/>
            <a:ext cx="88105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L= Weight Loss;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P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 Average of Weekly Minutes of Physical Activity; L-MFG/DLPFC= Left Middle Frontal Gyrus/Dorsal Lateral Prefrontal Cortex; R-MFG= Right Middle Frontal Gyrus</a:t>
            </a:r>
          </a:p>
        </p:txBody>
      </p:sp>
    </p:spTree>
    <p:extLst>
      <p:ext uri="{BB962C8B-B14F-4D97-AF65-F5344CB8AC3E}">
        <p14:creationId xmlns:p14="http://schemas.microsoft.com/office/powerpoint/2010/main" val="2012616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41</TotalTime>
  <Words>173</Words>
  <Application>Microsoft Office PowerPoint</Application>
  <PresentationFormat>Widescreen</PresentationFormat>
  <Paragraphs>1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Kansa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bo-Reed, Amanda Nicole</dc:creator>
  <cp:lastModifiedBy>Amanda Szabo</cp:lastModifiedBy>
  <cp:revision>67</cp:revision>
  <cp:lastPrinted>2015-04-15T13:03:16Z</cp:lastPrinted>
  <dcterms:created xsi:type="dcterms:W3CDTF">2015-02-17T16:32:13Z</dcterms:created>
  <dcterms:modified xsi:type="dcterms:W3CDTF">2019-12-20T17:14:24Z</dcterms:modified>
</cp:coreProperties>
</file>